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1" r:id="rId2"/>
    <p:sldId id="337" r:id="rId3"/>
    <p:sldId id="336" r:id="rId4"/>
    <p:sldId id="338" r:id="rId5"/>
    <p:sldId id="332" r:id="rId6"/>
    <p:sldId id="334" r:id="rId7"/>
    <p:sldId id="33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4" autoAdjust="0"/>
    <p:restoredTop sz="94660"/>
  </p:normalViewPr>
  <p:slideViewPr>
    <p:cSldViewPr snapToGrid="0">
      <p:cViewPr>
        <p:scale>
          <a:sx n="120" d="100"/>
          <a:sy n="120" d="100"/>
        </p:scale>
        <p:origin x="4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B8BDB5-075A-42CD-8BAE-340D477DBA65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D5F8C6-F11C-4F9F-AC20-1BA25AECBE5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65872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5356E-1FCC-7ACE-ED52-55022D86F7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B0E55C-3CEE-FB52-FDAB-8B7D755907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BEFBDC-D857-4B76-EBEE-35A47D3DF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67BF3B-4212-893E-6D89-456D318436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91A7A-8442-2CCD-C8E9-AC54DD732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3980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FD1C33-3E0C-A6D6-93EA-1C604E880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2395C3-E6C4-8852-3B49-01BC5B322C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0E5747-2619-EC89-19C7-F0B35A1E1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DE597-3A2A-720C-9904-71DE852F5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DBA79B-2F8C-5A51-17BD-FEB9BDCE5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9142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D3BC05-6858-9E07-EAF1-6E839B31FE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D00D53-B28D-D29C-758D-86F6405662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4D9700-FEF1-1D4E-D25E-8DAA943FF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3069C3-4E1A-F955-C9EA-5E939739F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05B9D7-5EE7-2E26-94C1-67CDBF285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04451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19DC6-9F25-C4B9-5220-5814DE13C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610600-2750-0274-46D3-91BBD9E0B8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F966A1-82F4-9F0D-3A8C-43CF89BFB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B8BA36-1A30-187B-395E-E525B92E3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F7007A-AEDB-2F68-72D0-BDB3F25C7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1485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0F6FF1-717A-4006-A7E2-78836D2CD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ADE535-B295-047A-7AC5-0E52B17720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B69BE2-18A4-FF3B-DCD5-2D430633B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6C2852-CD74-3819-2476-AB2F19082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F8F375-5517-3227-D826-44719C82D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25565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D401F2-DCA1-247F-692B-43C41BA287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2A78A2-06A1-3D35-03ED-EFF7D88D96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1A3763-6921-1236-49E5-04723C7DAD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E38402-E6EA-DC4A-E6F3-FD133C47C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261320-5C7C-AE69-48D9-63DF63832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0DC9AD-775B-8CE1-24B3-1F3598B40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3353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EA38B3-7345-7DC7-ACC2-4F53D8EF4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F1FB18-22DC-0897-6FA3-D257ECD77D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0A4382-3728-EA3C-7019-8E7AEE1B4D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442F01-E74E-0347-A4B2-F9D8399389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26D9D7-C6D8-5C18-E77D-02A47A4F34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23DB20-8AA0-0670-9402-AD7A6C9AC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A990C6-CBA9-DED8-AF7E-D73862536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7E14D2-6B45-E643-7A21-75685F52C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1400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07BDA1-1F4D-644F-3D0F-AED5F5118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0C7162-A211-EB15-2CEB-898760913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EEF71A-12F7-6138-5A77-48C6F7052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FEEBAB-F954-63C1-3CCE-8AEF80B38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8363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6BDEA2B-B9B1-8093-7C50-4A2379F47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512D94-CCFB-B8A5-693A-FDA2FA452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3C9F24-F644-DB29-6250-3A85BEDA5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5755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56E86-64E1-6B56-0A69-E6E1AD6325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B88621-9704-2EE9-C80B-16C8DBACDB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321955-8BC7-BBEA-E463-0A4F4BED3F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CFB11E-D9EC-7629-8F80-F6258876A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168A2F-0136-5ADD-D6A8-86F57D703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154E9F-0DB7-6E1B-BFC1-CD331F699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55238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A900BD-779E-AC37-4F45-9C176B3876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AFA07DE-F372-0DCD-E6E1-FCDAD7F6A7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DE9C49-941D-8EA3-91ED-9CBB2BD766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11C291-E1BD-C89C-3177-C6333D591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BC76D1-6F7A-9021-05D8-179314A5E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36CF20-94FE-4AD4-9FDD-70D338A5B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2735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0CFE57A-DA85-5CDF-4BF8-8441B460C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5694C0-83F0-D08C-B418-EEC9431406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663C5B-5BB3-AEC5-05FE-4944B09ACD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18027-E90C-4D8D-8C1C-1F4877C8297E}" type="datetimeFigureOut">
              <a:rPr lang="en-AU" smtClean="0"/>
              <a:t>15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82068A-1B52-8153-0E50-E55CE08774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E3B8A3-3218-DD19-D8E2-A24FB9D179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7F80E-0616-453A-921B-5832622CDE77}" type="slidenum">
              <a:rPr lang="en-AU" smtClean="0"/>
              <a:t>‹#›</a:t>
            </a:fld>
            <a:endParaRPr lang="en-AU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B8FD6E-5A9F-3A6A-43B5-13F9D918FA42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5752275" y="0"/>
            <a:ext cx="730250" cy="18288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AU"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FICIA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0EECD39-352F-FBD7-2709-BC31C41F7D61}"/>
              </a:ext>
            </a:extLst>
          </p:cNvPr>
          <p:cNvSpPr txBox="1"/>
          <p:nvPr>
            <p:extLst>
              <p:ext uri="{1162E1C5-73C7-4A58-AE30-91384D911F3F}">
                <p184:classification xmlns:p184="http://schemas.microsoft.com/office/powerpoint/2018/4/main" val="ftr"/>
              </p:ext>
            </p:extLst>
          </p:nvPr>
        </p:nvSpPr>
        <p:spPr>
          <a:xfrm>
            <a:off x="5820537" y="6675120"/>
            <a:ext cx="585788" cy="18288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AU" sz="12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FFICIAL</a:t>
            </a:r>
          </a:p>
        </p:txBody>
      </p:sp>
    </p:spTree>
    <p:extLst>
      <p:ext uri="{BB962C8B-B14F-4D97-AF65-F5344CB8AC3E}">
        <p14:creationId xmlns:p14="http://schemas.microsoft.com/office/powerpoint/2010/main" val="1923125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Rectangle 34">
            <a:extLst>
              <a:ext uri="{FF2B5EF4-FFF2-40B4-BE49-F238E27FC236}">
                <a16:creationId xmlns:a16="http://schemas.microsoft.com/office/drawing/2014/main" id="{FC275D73-FB34-F724-3891-377C80E6119C}"/>
              </a:ext>
            </a:extLst>
          </p:cNvPr>
          <p:cNvSpPr/>
          <p:nvPr/>
        </p:nvSpPr>
        <p:spPr>
          <a:xfrm>
            <a:off x="5610687" y="6578353"/>
            <a:ext cx="956655" cy="2707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43355B8-ABDC-C98C-B4E7-F8836E2B9D11}"/>
              </a:ext>
            </a:extLst>
          </p:cNvPr>
          <p:cNvSpPr/>
          <p:nvPr/>
        </p:nvSpPr>
        <p:spPr>
          <a:xfrm>
            <a:off x="5610687" y="0"/>
            <a:ext cx="956655" cy="2707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1144C1B-CA2F-A30B-EFE8-31FAE7E32C8B}"/>
              </a:ext>
            </a:extLst>
          </p:cNvPr>
          <p:cNvSpPr txBox="1"/>
          <p:nvPr/>
        </p:nvSpPr>
        <p:spPr>
          <a:xfrm>
            <a:off x="138310" y="620383"/>
            <a:ext cx="11689354" cy="310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600" i="1" dirty="0"/>
              <a:t>Vincent et al. 2024</a:t>
            </a:r>
          </a:p>
          <a:p>
            <a:pPr algn="ctr"/>
            <a:endParaRPr lang="en-US" sz="2400" dirty="0"/>
          </a:p>
          <a:p>
            <a:pPr algn="ctr"/>
            <a:r>
              <a:rPr lang="en-US" sz="2400" dirty="0"/>
              <a:t>“Integrated proteomics and metabolomics of safflower petal wilting and seed development”</a:t>
            </a:r>
          </a:p>
          <a:p>
            <a:pPr algn="ctr"/>
            <a:endParaRPr lang="en-US" sz="2400" dirty="0"/>
          </a:p>
          <a:p>
            <a:pPr algn="ctr"/>
            <a:r>
              <a:rPr lang="en-US" sz="8800" b="1" dirty="0"/>
              <a:t>Supplementary Figures</a:t>
            </a:r>
            <a:endParaRPr lang="en-AU" sz="8800" b="1" dirty="0"/>
          </a:p>
        </p:txBody>
      </p:sp>
    </p:spTree>
    <p:extLst>
      <p:ext uri="{BB962C8B-B14F-4D97-AF65-F5344CB8AC3E}">
        <p14:creationId xmlns:p14="http://schemas.microsoft.com/office/powerpoint/2010/main" val="316950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E22BF6-2A1C-3AB9-F5AB-EF3B4177330F}"/>
              </a:ext>
            </a:extLst>
          </p:cNvPr>
          <p:cNvSpPr txBox="1"/>
          <p:nvPr/>
        </p:nvSpPr>
        <p:spPr>
          <a:xfrm rot="16200000">
            <a:off x="-3198167" y="3151999"/>
            <a:ext cx="6858000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AU" sz="1000" b="1" dirty="0"/>
              <a:t>Supplementary Figure S1: Classification of metabolites using </a:t>
            </a:r>
            <a:r>
              <a:rPr lang="en-AU" sz="1000" b="1" dirty="0" err="1"/>
              <a:t>ClassyFire</a:t>
            </a:r>
            <a:r>
              <a:rPr lang="en-AU" sz="1000" b="1" dirty="0"/>
              <a:t> and of peptides using gene ontology and REVIGO. </a:t>
            </a:r>
            <a:r>
              <a:rPr lang="en-AU" sz="1000" dirty="0"/>
              <a:t>A. Metabolite superclasses displayed as a pie chart and classes plotted as a bar chart; B. Semantic similarities of GO IDs </a:t>
            </a:r>
            <a:r>
              <a:rPr lang="en-AU" sz="1000" dirty="0" err="1"/>
              <a:t>poltted</a:t>
            </a:r>
            <a:r>
              <a:rPr lang="en-AU" sz="1000" dirty="0"/>
              <a:t> as scatterplots and counts charted as </a:t>
            </a:r>
            <a:r>
              <a:rPr lang="en-AU" sz="1000" dirty="0" err="1"/>
              <a:t>treemaps</a:t>
            </a:r>
            <a:r>
              <a:rPr lang="en-AU" sz="1000" dirty="0"/>
              <a:t>.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EF5C97D4-E51F-E11D-45AF-ED3460046DD6}"/>
              </a:ext>
            </a:extLst>
          </p:cNvPr>
          <p:cNvGrpSpPr/>
          <p:nvPr/>
        </p:nvGrpSpPr>
        <p:grpSpPr>
          <a:xfrm>
            <a:off x="569845" y="17755"/>
            <a:ext cx="8024117" cy="6816052"/>
            <a:chOff x="667820" y="-2"/>
            <a:chExt cx="8024117" cy="6858002"/>
          </a:xfrm>
        </p:grpSpPr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4A406C33-AFE6-1B55-6312-AE55F08466F6}"/>
                </a:ext>
              </a:extLst>
            </p:cNvPr>
            <p:cNvSpPr/>
            <p:nvPr/>
          </p:nvSpPr>
          <p:spPr>
            <a:xfrm>
              <a:off x="719190" y="0"/>
              <a:ext cx="7972747" cy="685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592DA7BA-E035-E366-9647-C150FD4999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252" b="331"/>
            <a:stretch/>
          </p:blipFill>
          <p:spPr>
            <a:xfrm rot="16200000">
              <a:off x="-706847" y="1702593"/>
              <a:ext cx="6720775" cy="3452811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7AA56B6-45C3-8AB0-2DB2-BBFCBF78A8A3}"/>
                </a:ext>
              </a:extLst>
            </p:cNvPr>
            <p:cNvSpPr txBox="1"/>
            <p:nvPr/>
          </p:nvSpPr>
          <p:spPr>
            <a:xfrm rot="16200000">
              <a:off x="690422" y="6511270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61E0475-D128-614A-09B1-6127981A73CB}"/>
                </a:ext>
              </a:extLst>
            </p:cNvPr>
            <p:cNvSpPr txBox="1"/>
            <p:nvPr/>
          </p:nvSpPr>
          <p:spPr>
            <a:xfrm rot="16200000">
              <a:off x="4403887" y="6511270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B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88F2E9C0-5094-720F-D2D1-7216C5180BC3}"/>
                </a:ext>
              </a:extLst>
            </p:cNvPr>
            <p:cNvCxnSpPr/>
            <p:nvPr/>
          </p:nvCxnSpPr>
          <p:spPr>
            <a:xfrm>
              <a:off x="4438429" y="-2"/>
              <a:ext cx="0" cy="685800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08D0BC6D-A6AE-CC79-5A33-DED16E9418F3}"/>
                </a:ext>
              </a:extLst>
            </p:cNvPr>
            <p:cNvSpPr/>
            <p:nvPr/>
          </p:nvSpPr>
          <p:spPr>
            <a:xfrm>
              <a:off x="1130157" y="68610"/>
              <a:ext cx="1643865" cy="127730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4588E36B-D243-CEAC-6E0E-6C6AE07844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6200000">
              <a:off x="3319961" y="1427137"/>
              <a:ext cx="6760202" cy="396429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5261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6566225-D017-1300-AC49-3349B5B9727E}"/>
              </a:ext>
            </a:extLst>
          </p:cNvPr>
          <p:cNvSpPr txBox="1"/>
          <p:nvPr/>
        </p:nvSpPr>
        <p:spPr>
          <a:xfrm>
            <a:off x="0" y="0"/>
            <a:ext cx="3047999" cy="178510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AU" sz="1000" b="1" dirty="0"/>
              <a:t>Supplementary Figure S2: Data mining reveals molecular </a:t>
            </a:r>
            <a:r>
              <a:rPr lang="en-AU" sz="1000" b="1" dirty="0" err="1"/>
              <a:t>molecular</a:t>
            </a:r>
            <a:r>
              <a:rPr lang="en-AU" sz="1000" b="1" dirty="0"/>
              <a:t> shifts in safflower wilting petals. </a:t>
            </a:r>
            <a:r>
              <a:rPr lang="en-AU" sz="1000" dirty="0"/>
              <a:t>A-C. </a:t>
            </a:r>
            <a:r>
              <a:rPr lang="en-AU" sz="1000" dirty="0" err="1"/>
              <a:t>Treemap</a:t>
            </a:r>
            <a:r>
              <a:rPr lang="en-AU" sz="1000" dirty="0"/>
              <a:t> bar charts of GO classes and IDs of the peptides specific to petals (A), most significant (p-value&lt;0.05, SOM distance &lt;0.005) SOM cluster (1,2) (B) and SOM cluster (1,1) (C); D-F. Stacked column charts of superclasses and classes of the metabolites specific to petals (D), most significant (p-value&lt;0.05, SOM distance &lt;0.005) SOM cluster (1,2) (E) and SOM cluster (1,1) (F); G. Quantitative profiles of safflower pigments in petals over stages 1-3. Vertical bars represent SD.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AB1E4D4F-F7F6-1BFF-472B-059738B75781}"/>
              </a:ext>
            </a:extLst>
          </p:cNvPr>
          <p:cNvGrpSpPr/>
          <p:nvPr/>
        </p:nvGrpSpPr>
        <p:grpSpPr>
          <a:xfrm>
            <a:off x="3059855" y="-49599"/>
            <a:ext cx="9132145" cy="6869499"/>
            <a:chOff x="3059855" y="-49599"/>
            <a:chExt cx="9132145" cy="6869499"/>
          </a:xfrm>
        </p:grpSpPr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D0688695-9F5B-1B51-E6F3-124F7FDBF7D0}"/>
                </a:ext>
              </a:extLst>
            </p:cNvPr>
            <p:cNvGrpSpPr/>
            <p:nvPr/>
          </p:nvGrpSpPr>
          <p:grpSpPr>
            <a:xfrm>
              <a:off x="3059855" y="-49599"/>
              <a:ext cx="9132145" cy="6869499"/>
              <a:chOff x="3059855" y="-49599"/>
              <a:chExt cx="9132145" cy="6869499"/>
            </a:xfrm>
          </p:grpSpPr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A3156CCA-7D97-C67E-1355-EE7B06E71EA2}"/>
                  </a:ext>
                </a:extLst>
              </p:cNvPr>
              <p:cNvSpPr/>
              <p:nvPr/>
            </p:nvSpPr>
            <p:spPr>
              <a:xfrm>
                <a:off x="3091115" y="28574"/>
                <a:ext cx="9012901" cy="6791325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6D775601-CB57-2868-E3DF-AB7AAFB1D3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123802" y="216990"/>
                <a:ext cx="7369900" cy="3334960"/>
              </a:xfrm>
              <a:prstGeom prst="rect">
                <a:avLst/>
              </a:prstGeom>
            </p:spPr>
          </p:pic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D874708E-6B02-768D-18A2-119FFFC91686}"/>
                  </a:ext>
                </a:extLst>
              </p:cNvPr>
              <p:cNvGrpSpPr/>
              <p:nvPr/>
            </p:nvGrpSpPr>
            <p:grpSpPr>
              <a:xfrm>
                <a:off x="10635584" y="44959"/>
                <a:ext cx="1556416" cy="6765415"/>
                <a:chOff x="6078412" y="283662"/>
                <a:chExt cx="1556416" cy="6574336"/>
              </a:xfrm>
            </p:grpSpPr>
            <p:pic>
              <p:nvPicPr>
                <p:cNvPr id="46" name="Picture 45">
                  <a:extLst>
                    <a:ext uri="{FF2B5EF4-FFF2-40B4-BE49-F238E27FC236}">
                      <a16:creationId xmlns:a16="http://schemas.microsoft.com/office/drawing/2014/main" id="{FBE5FD8D-948F-C4D3-DD8D-9FB29FD09A0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6103161" y="294822"/>
                  <a:ext cx="1367483" cy="6563176"/>
                </a:xfrm>
                <a:prstGeom prst="rect">
                  <a:avLst/>
                </a:prstGeom>
              </p:spPr>
            </p:pic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F316C5A4-2E24-DCAC-6DA8-DCFC36D84633}"/>
                    </a:ext>
                  </a:extLst>
                </p:cNvPr>
                <p:cNvSpPr txBox="1"/>
                <p:nvPr/>
              </p:nvSpPr>
              <p:spPr>
                <a:xfrm>
                  <a:off x="6078412" y="5533133"/>
                  <a:ext cx="891174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AU" sz="1000" b="1" dirty="0" err="1">
                      <a:solidFill>
                        <a:srgbClr val="00B0F0"/>
                      </a:solidFill>
                    </a:rPr>
                    <a:t>Safflomin</a:t>
                  </a:r>
                  <a:r>
                    <a:rPr lang="en-AU" sz="1000" b="1" dirty="0">
                      <a:solidFill>
                        <a:srgbClr val="00B0F0"/>
                      </a:solidFill>
                    </a:rPr>
                    <a:t> C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841FCCEE-DD67-3AFB-7EEB-30176D3E156C}"/>
                    </a:ext>
                  </a:extLst>
                </p:cNvPr>
                <p:cNvSpPr txBox="1"/>
                <p:nvPr/>
              </p:nvSpPr>
              <p:spPr>
                <a:xfrm>
                  <a:off x="6078412" y="1596030"/>
                  <a:ext cx="1556416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AU" sz="1000" b="1" dirty="0" err="1">
                      <a:solidFill>
                        <a:srgbClr val="00B0F0"/>
                      </a:solidFill>
                    </a:rPr>
                    <a:t>Anhydrosafflor</a:t>
                  </a:r>
                  <a:r>
                    <a:rPr lang="en-AU" sz="1000" b="1" dirty="0">
                      <a:solidFill>
                        <a:srgbClr val="00B0F0"/>
                      </a:solidFill>
                    </a:rPr>
                    <a:t> Yellow B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AB31D640-05F2-FF10-2025-F6B4ACFB714E}"/>
                    </a:ext>
                  </a:extLst>
                </p:cNvPr>
                <p:cNvSpPr txBox="1"/>
                <p:nvPr/>
              </p:nvSpPr>
              <p:spPr>
                <a:xfrm>
                  <a:off x="6078412" y="2908398"/>
                  <a:ext cx="876002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AU" sz="1000" b="1" dirty="0" err="1">
                      <a:solidFill>
                        <a:srgbClr val="00B0F0"/>
                      </a:solidFill>
                    </a:rPr>
                    <a:t>Carthamin</a:t>
                  </a:r>
                  <a:endParaRPr lang="en-AU" sz="1000" b="1" dirty="0">
                    <a:solidFill>
                      <a:srgbClr val="00B0F0"/>
                    </a:solidFill>
                  </a:endParaRP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947901D7-431B-B074-65D8-1D052EE5D839}"/>
                    </a:ext>
                  </a:extLst>
                </p:cNvPr>
                <p:cNvSpPr txBox="1"/>
                <p:nvPr/>
              </p:nvSpPr>
              <p:spPr>
                <a:xfrm>
                  <a:off x="6078412" y="4220766"/>
                  <a:ext cx="891174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AU" sz="1000" b="1" dirty="0" err="1">
                      <a:solidFill>
                        <a:srgbClr val="00B0F0"/>
                      </a:solidFill>
                    </a:rPr>
                    <a:t>Safflomin</a:t>
                  </a:r>
                  <a:r>
                    <a:rPr lang="en-AU" sz="1000" b="1" dirty="0">
                      <a:solidFill>
                        <a:srgbClr val="00B0F0"/>
                      </a:solidFill>
                    </a:rPr>
                    <a:t> C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09325643-9F36-D28B-1B5D-9BC1F44C486D}"/>
                    </a:ext>
                  </a:extLst>
                </p:cNvPr>
                <p:cNvSpPr txBox="1"/>
                <p:nvPr/>
              </p:nvSpPr>
              <p:spPr>
                <a:xfrm>
                  <a:off x="6078412" y="283662"/>
                  <a:ext cx="1088918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AU" sz="1000" b="1" dirty="0" err="1">
                      <a:solidFill>
                        <a:srgbClr val="00B0F0"/>
                      </a:solidFill>
                    </a:rPr>
                    <a:t>Safflor</a:t>
                  </a:r>
                  <a:r>
                    <a:rPr lang="en-AU" sz="1000" b="1" dirty="0">
                      <a:solidFill>
                        <a:srgbClr val="00B0F0"/>
                      </a:solidFill>
                    </a:rPr>
                    <a:t> Yellow B</a:t>
                  </a:r>
                </a:p>
              </p:txBody>
            </p:sp>
          </p:grp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4EC7FBA3-B202-EEA3-1D4F-26A5A221E1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06075" y="30994"/>
                <a:ext cx="0" cy="678890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208DFC66-C04B-ADA3-8C1B-84FB3D0EEE95}"/>
                  </a:ext>
                </a:extLst>
              </p:cNvPr>
              <p:cNvSpPr txBox="1"/>
              <p:nvPr/>
            </p:nvSpPr>
            <p:spPr>
              <a:xfrm>
                <a:off x="3069380" y="3491503"/>
                <a:ext cx="330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D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CF8A4C2-BE0E-FBAD-075E-350E8C04B537}"/>
                  </a:ext>
                </a:extLst>
              </p:cNvPr>
              <p:cNvSpPr txBox="1"/>
              <p:nvPr/>
            </p:nvSpPr>
            <p:spPr>
              <a:xfrm>
                <a:off x="5840582" y="3491503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E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92D23AB0-C27F-79EB-996F-091232CAD1C1}"/>
                  </a:ext>
                </a:extLst>
              </p:cNvPr>
              <p:cNvSpPr txBox="1"/>
              <p:nvPr/>
            </p:nvSpPr>
            <p:spPr>
              <a:xfrm>
                <a:off x="8138204" y="3491503"/>
                <a:ext cx="2904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F</a:t>
                </a:r>
              </a:p>
            </p:txBody>
          </p: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1B390A44-D49B-ACD2-2425-F46F775F53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91115" y="3551950"/>
                <a:ext cx="740042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7E76FE85-EB4D-604D-7D3B-99F96DD9EC43}"/>
                  </a:ext>
                </a:extLst>
              </p:cNvPr>
              <p:cNvGrpSpPr/>
              <p:nvPr/>
            </p:nvGrpSpPr>
            <p:grpSpPr>
              <a:xfrm>
                <a:off x="5631482" y="28262"/>
                <a:ext cx="2439344" cy="3515033"/>
                <a:chOff x="4760116" y="220611"/>
                <a:chExt cx="2851800" cy="3365262"/>
              </a:xfrm>
            </p:grpSpPr>
            <p:cxnSp>
              <p:nvCxnSpPr>
                <p:cNvPr id="34" name="Straight Connector 33">
                  <a:extLst>
                    <a:ext uri="{FF2B5EF4-FFF2-40B4-BE49-F238E27FC236}">
                      <a16:creationId xmlns:a16="http://schemas.microsoft.com/office/drawing/2014/main" id="{2BECCFB8-61FA-1CEB-22D9-6841A2C355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60116" y="220611"/>
                  <a:ext cx="0" cy="33652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Connector 42">
                  <a:extLst>
                    <a:ext uri="{FF2B5EF4-FFF2-40B4-BE49-F238E27FC236}">
                      <a16:creationId xmlns:a16="http://schemas.microsoft.com/office/drawing/2014/main" id="{D1B6E484-E969-C4FA-FCEC-D7FA35B592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611916" y="220611"/>
                  <a:ext cx="0" cy="33652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01AB3465-B72F-F51B-07F5-A29CE42A60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105339" y="3761376"/>
                <a:ext cx="7384765" cy="3043821"/>
              </a:xfrm>
              <a:prstGeom prst="rect">
                <a:avLst/>
              </a:prstGeom>
            </p:spPr>
          </p:pic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D132E3E0-DD8E-79D6-AF1E-4E6B3D786774}"/>
                  </a:ext>
                </a:extLst>
              </p:cNvPr>
              <p:cNvGrpSpPr/>
              <p:nvPr/>
            </p:nvGrpSpPr>
            <p:grpSpPr>
              <a:xfrm>
                <a:off x="5877869" y="3563886"/>
                <a:ext cx="2305391" cy="3256014"/>
                <a:chOff x="5325419" y="220611"/>
                <a:chExt cx="2305391" cy="3365262"/>
              </a:xfrm>
            </p:grpSpPr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785689BF-577D-FD8C-D1B1-A912046B92A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25419" y="220611"/>
                  <a:ext cx="0" cy="33652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D85C930D-4480-FA0F-2B78-7F047C69DE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630810" y="220611"/>
                  <a:ext cx="0" cy="336526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0F782CD9-E121-44C7-A15C-3DE9BA30977C}"/>
                  </a:ext>
                </a:extLst>
              </p:cNvPr>
              <p:cNvSpPr txBox="1"/>
              <p:nvPr/>
            </p:nvSpPr>
            <p:spPr>
              <a:xfrm>
                <a:off x="10444293" y="-49599"/>
                <a:ext cx="33214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G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87EB90F5-316C-185E-59D4-97B238A90E86}"/>
                  </a:ext>
                </a:extLst>
              </p:cNvPr>
              <p:cNvSpPr txBox="1"/>
              <p:nvPr/>
            </p:nvSpPr>
            <p:spPr>
              <a:xfrm>
                <a:off x="3059855" y="-49599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A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8DD926A7-3EA2-1064-9E9B-403BD101C547}"/>
                  </a:ext>
                </a:extLst>
              </p:cNvPr>
              <p:cNvSpPr txBox="1"/>
              <p:nvPr/>
            </p:nvSpPr>
            <p:spPr>
              <a:xfrm>
                <a:off x="5587420" y="-49599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B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119ED9B-22BF-1DE2-03F0-6734A5955634}"/>
                  </a:ext>
                </a:extLst>
              </p:cNvPr>
              <p:cNvSpPr txBox="1"/>
              <p:nvPr/>
            </p:nvSpPr>
            <p:spPr>
              <a:xfrm>
                <a:off x="8046374" y="-49599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C</a:t>
                </a:r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B9F44A14-0886-91B4-5459-C358F3A492E5}"/>
                </a:ext>
              </a:extLst>
            </p:cNvPr>
            <p:cNvGrpSpPr/>
            <p:nvPr/>
          </p:nvGrpSpPr>
          <p:grpSpPr>
            <a:xfrm>
              <a:off x="6206614" y="4086837"/>
              <a:ext cx="4239507" cy="2308081"/>
              <a:chOff x="6206614" y="4086837"/>
              <a:chExt cx="4239507" cy="2308081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704F2B2C-C357-AD34-4CF7-45A5AF7B99B8}"/>
                  </a:ext>
                </a:extLst>
              </p:cNvPr>
              <p:cNvSpPr txBox="1"/>
              <p:nvPr/>
            </p:nvSpPr>
            <p:spPr>
              <a:xfrm>
                <a:off x="6405933" y="6124354"/>
                <a:ext cx="17938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Fatty acyls</a:t>
                </a:r>
                <a:endParaRPr lang="en-AU" sz="500" dirty="0"/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3E813804-82C6-98E6-9D0D-134509824613}"/>
                  </a:ext>
                </a:extLst>
              </p:cNvPr>
              <p:cNvSpPr txBox="1"/>
              <p:nvPr/>
            </p:nvSpPr>
            <p:spPr>
              <a:xfrm>
                <a:off x="6405933" y="5597399"/>
                <a:ext cx="17938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 err="1">
                    <a:solidFill>
                      <a:schemeClr val="bg1"/>
                    </a:solidFill>
                  </a:rPr>
                  <a:t>Prenol</a:t>
                </a:r>
                <a:r>
                  <a:rPr lang="en-US" sz="500" dirty="0">
                    <a:solidFill>
                      <a:schemeClr val="bg1"/>
                    </a:solidFill>
                  </a:rPr>
                  <a:t> lipids</a:t>
                </a:r>
                <a:endParaRPr lang="en-AU" sz="5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F5DC2DD-336A-A367-358A-610C89ED5927}"/>
                  </a:ext>
                </a:extLst>
              </p:cNvPr>
              <p:cNvSpPr txBox="1"/>
              <p:nvPr/>
            </p:nvSpPr>
            <p:spPr>
              <a:xfrm>
                <a:off x="6381102" y="5317973"/>
                <a:ext cx="216399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Steroids</a:t>
                </a:r>
                <a:endParaRPr lang="en-AU" sz="500" dirty="0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A7ADE1E-DBAB-5775-A2ED-40FA9FE4935F}"/>
                  </a:ext>
                </a:extLst>
              </p:cNvPr>
              <p:cNvSpPr txBox="1"/>
              <p:nvPr/>
            </p:nvSpPr>
            <p:spPr>
              <a:xfrm>
                <a:off x="6206614" y="5904226"/>
                <a:ext cx="56537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 err="1"/>
                  <a:t>Glycero</a:t>
                </a:r>
                <a:endParaRPr lang="en-US" sz="500" dirty="0"/>
              </a:p>
              <a:p>
                <a:pPr algn="ctr"/>
                <a:r>
                  <a:rPr lang="en-US" sz="500" dirty="0"/>
                  <a:t>phospholipids</a:t>
                </a:r>
                <a:endParaRPr lang="en-AU" sz="500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588A49C-E89C-420F-0D88-5C8B8169BE33}"/>
                  </a:ext>
                </a:extLst>
              </p:cNvPr>
              <p:cNvSpPr txBox="1"/>
              <p:nvPr/>
            </p:nvSpPr>
            <p:spPr>
              <a:xfrm>
                <a:off x="6707506" y="6085882"/>
                <a:ext cx="278083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Flavonoids</a:t>
                </a:r>
                <a:endParaRPr lang="en-AU" sz="500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5B15946-CB0D-EFB7-8BAC-070FA877FF88}"/>
                  </a:ext>
                </a:extLst>
              </p:cNvPr>
              <p:cNvSpPr txBox="1"/>
              <p:nvPr/>
            </p:nvSpPr>
            <p:spPr>
              <a:xfrm>
                <a:off x="7056652" y="6254459"/>
                <a:ext cx="284329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>
                    <a:solidFill>
                      <a:schemeClr val="bg1"/>
                    </a:solidFill>
                  </a:rPr>
                  <a:t>Benzenes</a:t>
                </a:r>
                <a:endParaRPr lang="en-AU" sz="5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A96E4A2-E399-3A20-75D8-665038E28780}"/>
                  </a:ext>
                </a:extLst>
              </p:cNvPr>
              <p:cNvSpPr txBox="1"/>
              <p:nvPr/>
            </p:nvSpPr>
            <p:spPr>
              <a:xfrm>
                <a:off x="7086646" y="6008401"/>
                <a:ext cx="216399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>
                    <a:solidFill>
                      <a:schemeClr val="bg1"/>
                    </a:solidFill>
                  </a:rPr>
                  <a:t>Phenols</a:t>
                </a:r>
                <a:endParaRPr lang="en-AU" sz="5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8DE149F-31F3-4297-5248-04D85600288C}"/>
                  </a:ext>
                </a:extLst>
              </p:cNvPr>
              <p:cNvSpPr txBox="1"/>
              <p:nvPr/>
            </p:nvSpPr>
            <p:spPr>
              <a:xfrm>
                <a:off x="7388915" y="6215987"/>
                <a:ext cx="319646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Carboxylic acids</a:t>
                </a:r>
                <a:endParaRPr lang="en-AU" sz="500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0FC38959-4326-22DC-EBDE-770350C412D8}"/>
                  </a:ext>
                </a:extLst>
              </p:cNvPr>
              <p:cNvSpPr txBox="1"/>
              <p:nvPr/>
            </p:nvSpPr>
            <p:spPr>
              <a:xfrm>
                <a:off x="7747279" y="6297962"/>
                <a:ext cx="364343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Benzopyrans</a:t>
                </a:r>
                <a:endParaRPr lang="en-AU" sz="500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2FE4B8E-498A-0CA3-03D0-7F0E79FC1214}"/>
                  </a:ext>
                </a:extLst>
              </p:cNvPr>
              <p:cNvSpPr txBox="1"/>
              <p:nvPr/>
            </p:nvSpPr>
            <p:spPr>
              <a:xfrm>
                <a:off x="6701440" y="6239770"/>
                <a:ext cx="278083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>
                    <a:solidFill>
                      <a:schemeClr val="bg1"/>
                    </a:solidFill>
                  </a:rPr>
                  <a:t>Coumarins</a:t>
                </a:r>
                <a:endParaRPr lang="en-AU" sz="5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5897873-A4CE-4523-E224-EE20FCA10ACB}"/>
                  </a:ext>
                </a:extLst>
              </p:cNvPr>
              <p:cNvSpPr txBox="1"/>
              <p:nvPr/>
            </p:nvSpPr>
            <p:spPr>
              <a:xfrm>
                <a:off x="8728752" y="5882048"/>
                <a:ext cx="17938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Fatty acyls</a:t>
                </a:r>
                <a:endParaRPr lang="en-AU" sz="500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C929647-D707-AE4F-BA14-E924F1BCD277}"/>
                  </a:ext>
                </a:extLst>
              </p:cNvPr>
              <p:cNvSpPr txBox="1"/>
              <p:nvPr/>
            </p:nvSpPr>
            <p:spPr>
              <a:xfrm>
                <a:off x="8728752" y="4584230"/>
                <a:ext cx="17938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 err="1">
                    <a:solidFill>
                      <a:schemeClr val="bg1"/>
                    </a:solidFill>
                  </a:rPr>
                  <a:t>Prenol</a:t>
                </a:r>
                <a:r>
                  <a:rPr lang="en-US" sz="500" dirty="0">
                    <a:solidFill>
                      <a:schemeClr val="bg1"/>
                    </a:solidFill>
                  </a:rPr>
                  <a:t> lipids</a:t>
                </a:r>
                <a:endParaRPr lang="en-AU" sz="5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0454D278-D683-A3F0-C5FC-F2413EAB7AD2}"/>
                  </a:ext>
                </a:extLst>
              </p:cNvPr>
              <p:cNvSpPr txBox="1"/>
              <p:nvPr/>
            </p:nvSpPr>
            <p:spPr>
              <a:xfrm>
                <a:off x="8703921" y="4086837"/>
                <a:ext cx="216399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Steroids</a:t>
                </a:r>
                <a:endParaRPr lang="en-AU" sz="500" dirty="0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2999531-71CF-F52E-A1E7-E666BA0F4CB9}"/>
                  </a:ext>
                </a:extLst>
              </p:cNvPr>
              <p:cNvSpPr txBox="1"/>
              <p:nvPr/>
            </p:nvSpPr>
            <p:spPr>
              <a:xfrm>
                <a:off x="8529433" y="4954849"/>
                <a:ext cx="56537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 err="1"/>
                  <a:t>Glycero</a:t>
                </a:r>
                <a:endParaRPr lang="en-US" sz="500" dirty="0"/>
              </a:p>
              <a:p>
                <a:pPr algn="ctr"/>
                <a:r>
                  <a:rPr lang="en-US" sz="500" dirty="0"/>
                  <a:t>phospholipids</a:t>
                </a:r>
                <a:endParaRPr lang="en-AU" sz="5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88FF1C02-3ADC-F9F7-2876-E0DB09FA3A43}"/>
                  </a:ext>
                </a:extLst>
              </p:cNvPr>
              <p:cNvSpPr txBox="1"/>
              <p:nvPr/>
            </p:nvSpPr>
            <p:spPr>
              <a:xfrm>
                <a:off x="8563286" y="5108737"/>
                <a:ext cx="565374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 err="1">
                    <a:solidFill>
                      <a:schemeClr val="bg1"/>
                    </a:solidFill>
                  </a:rPr>
                  <a:t>Glycerolipids</a:t>
                </a:r>
                <a:endParaRPr lang="en-AU" sz="5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3ED4634-9B7B-C76C-89F3-E1C5935BE95A}"/>
                  </a:ext>
                </a:extLst>
              </p:cNvPr>
              <p:cNvSpPr txBox="1"/>
              <p:nvPr/>
            </p:nvSpPr>
            <p:spPr>
              <a:xfrm>
                <a:off x="9028029" y="6089977"/>
                <a:ext cx="284329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>
                    <a:solidFill>
                      <a:schemeClr val="bg1"/>
                    </a:solidFill>
                  </a:rPr>
                  <a:t>Benzenes</a:t>
                </a:r>
                <a:endParaRPr lang="en-AU" sz="5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5B1876C-3154-D3FF-00DF-869EFEB8CB54}"/>
                  </a:ext>
                </a:extLst>
              </p:cNvPr>
              <p:cNvSpPr txBox="1"/>
              <p:nvPr/>
            </p:nvSpPr>
            <p:spPr>
              <a:xfrm>
                <a:off x="9068655" y="5700380"/>
                <a:ext cx="216399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>
                    <a:solidFill>
                      <a:schemeClr val="bg1"/>
                    </a:solidFill>
                  </a:rPr>
                  <a:t>Phenols</a:t>
                </a:r>
                <a:endParaRPr lang="en-AU" sz="5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6C17EAAB-96C7-B736-F934-E469113878AA}"/>
                  </a:ext>
                </a:extLst>
              </p:cNvPr>
              <p:cNvSpPr txBox="1"/>
              <p:nvPr/>
            </p:nvSpPr>
            <p:spPr>
              <a:xfrm>
                <a:off x="9374140" y="6085345"/>
                <a:ext cx="278083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Flavonoids</a:t>
                </a:r>
                <a:endParaRPr lang="en-AU" sz="500" dirty="0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4D551D56-1D82-F167-3A93-F36AEFBA4853}"/>
                  </a:ext>
                </a:extLst>
              </p:cNvPr>
              <p:cNvSpPr txBox="1"/>
              <p:nvPr/>
            </p:nvSpPr>
            <p:spPr>
              <a:xfrm>
                <a:off x="9390855" y="6241030"/>
                <a:ext cx="27808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Cinnamic acid</a:t>
                </a:r>
                <a:endParaRPr lang="en-AU" sz="500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4D03D638-0966-1659-6890-B332784F6538}"/>
                  </a:ext>
                </a:extLst>
              </p:cNvPr>
              <p:cNvSpPr txBox="1"/>
              <p:nvPr/>
            </p:nvSpPr>
            <p:spPr>
              <a:xfrm>
                <a:off x="9694618" y="6052798"/>
                <a:ext cx="430610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 err="1"/>
                  <a:t>Naphotfurans</a:t>
                </a:r>
                <a:endParaRPr lang="en-AU" sz="500" dirty="0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3E5D9664-E1A5-F16F-D6C6-3F68BB08BF4D}"/>
                  </a:ext>
                </a:extLst>
              </p:cNvPr>
              <p:cNvSpPr txBox="1"/>
              <p:nvPr/>
            </p:nvSpPr>
            <p:spPr>
              <a:xfrm>
                <a:off x="10022178" y="6309566"/>
                <a:ext cx="423943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500" dirty="0"/>
                  <a:t>Carboxylic acids</a:t>
                </a:r>
                <a:endParaRPr lang="en-AU" sz="5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200267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6566225-D017-1300-AC49-3349B5B9727E}"/>
              </a:ext>
            </a:extLst>
          </p:cNvPr>
          <p:cNvSpPr txBox="1"/>
          <p:nvPr/>
        </p:nvSpPr>
        <p:spPr>
          <a:xfrm>
            <a:off x="0" y="0"/>
            <a:ext cx="3379496" cy="178510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AU" sz="1000" b="1" dirty="0"/>
              <a:t>Supplementary Figure S3: Data mining reveals molecular </a:t>
            </a:r>
            <a:r>
              <a:rPr lang="en-AU" sz="1000" b="1" dirty="0" err="1"/>
              <a:t>molecular</a:t>
            </a:r>
            <a:r>
              <a:rPr lang="en-AU" sz="1000" b="1" dirty="0"/>
              <a:t> shifts in developing seeds up to full maturity. </a:t>
            </a:r>
            <a:r>
              <a:rPr lang="en-AU" sz="1000" dirty="0"/>
              <a:t>A-D. </a:t>
            </a:r>
            <a:r>
              <a:rPr lang="en-AU" sz="1000" dirty="0" err="1"/>
              <a:t>Treemap</a:t>
            </a:r>
            <a:r>
              <a:rPr lang="en-AU" sz="1000" dirty="0"/>
              <a:t> bar charts of GO classes and IDs of the peptides specific to petals (A), most significant (p-value&lt;0.05, SOM distance &lt;0.005) SOM cluster (1,1) (B), SOM cluster (1,2) (C), and SOM cluster (1,3) (D); E-H. Stacked column charts of superclasses and classes of the metabolites specific to petals (E), most significant (p-value&lt;0.05, SOM distance &lt;0.005) SOM cluster (1,1) (F), SOM cluster (1,2) (G), and SOM cluster (1,3) (H); I. Quantitative profiles of safflower proteins in developing seeds. Vertical bars represent SD.</a:t>
            </a:r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9FF4D297-5417-C13B-B488-5ADFE5D9F52F}"/>
              </a:ext>
            </a:extLst>
          </p:cNvPr>
          <p:cNvGrpSpPr/>
          <p:nvPr/>
        </p:nvGrpSpPr>
        <p:grpSpPr>
          <a:xfrm>
            <a:off x="3361619" y="-49599"/>
            <a:ext cx="8792622" cy="6869499"/>
            <a:chOff x="3361619" y="-49599"/>
            <a:chExt cx="8792622" cy="6869499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98C336EE-2530-484E-AB80-9E1A7ED54272}"/>
                </a:ext>
              </a:extLst>
            </p:cNvPr>
            <p:cNvGrpSpPr/>
            <p:nvPr/>
          </p:nvGrpSpPr>
          <p:grpSpPr>
            <a:xfrm>
              <a:off x="3361619" y="-49599"/>
              <a:ext cx="8792622" cy="6869499"/>
              <a:chOff x="3361619" y="-49599"/>
              <a:chExt cx="8792622" cy="6869499"/>
            </a:xfrm>
          </p:grpSpPr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4F46EA3D-D1EC-AF3C-5B98-0CA150E13292}"/>
                  </a:ext>
                </a:extLst>
              </p:cNvPr>
              <p:cNvSpPr/>
              <p:nvPr/>
            </p:nvSpPr>
            <p:spPr>
              <a:xfrm>
                <a:off x="3402405" y="28574"/>
                <a:ext cx="8751836" cy="6791325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0D921BE7-165C-F52A-45BC-728B2E975E06}"/>
                  </a:ext>
                </a:extLst>
              </p:cNvPr>
              <p:cNvSpPr txBox="1"/>
              <p:nvPr/>
            </p:nvSpPr>
            <p:spPr>
              <a:xfrm>
                <a:off x="3371144" y="-49599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A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77EA825C-1786-1B8B-1F91-6BFC94959CD6}"/>
                  </a:ext>
                </a:extLst>
              </p:cNvPr>
              <p:cNvSpPr txBox="1"/>
              <p:nvPr/>
            </p:nvSpPr>
            <p:spPr>
              <a:xfrm>
                <a:off x="5146234" y="-49599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B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752D6C79-36C0-88FD-97F3-CF567500C7AC}"/>
                  </a:ext>
                </a:extLst>
              </p:cNvPr>
              <p:cNvSpPr txBox="1"/>
              <p:nvPr/>
            </p:nvSpPr>
            <p:spPr>
              <a:xfrm>
                <a:off x="6938438" y="-49599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C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E1EEC6E-05AB-93C9-0347-EA25DD36FB00}"/>
                  </a:ext>
                </a:extLst>
              </p:cNvPr>
              <p:cNvSpPr txBox="1"/>
              <p:nvPr/>
            </p:nvSpPr>
            <p:spPr>
              <a:xfrm>
                <a:off x="3361619" y="3491503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E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E54A0A1-66AB-1C83-62DD-B2885212478B}"/>
                  </a:ext>
                </a:extLst>
              </p:cNvPr>
              <p:cNvSpPr txBox="1"/>
              <p:nvPr/>
            </p:nvSpPr>
            <p:spPr>
              <a:xfrm>
                <a:off x="5532746" y="3491503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F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DB74E58E-CB14-3CEF-DA7B-0D025D1670EE}"/>
                  </a:ext>
                </a:extLst>
              </p:cNvPr>
              <p:cNvSpPr txBox="1"/>
              <p:nvPr/>
            </p:nvSpPr>
            <p:spPr>
              <a:xfrm>
                <a:off x="7222184" y="3491503"/>
                <a:ext cx="33214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G</a:t>
                </a:r>
              </a:p>
            </p:txBody>
          </p:sp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C685013D-82D0-8675-DE5C-74E5718A8F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438097" y="216056"/>
                <a:ext cx="7117077" cy="3325495"/>
              </a:xfrm>
              <a:prstGeom prst="rect">
                <a:avLst/>
              </a:prstGeom>
            </p:spPr>
          </p:pic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6B093F96-66B0-FB7A-2578-7974A1FBF8AE}"/>
                  </a:ext>
                </a:extLst>
              </p:cNvPr>
              <p:cNvGrpSpPr/>
              <p:nvPr/>
            </p:nvGrpSpPr>
            <p:grpSpPr>
              <a:xfrm>
                <a:off x="5199821" y="28261"/>
                <a:ext cx="3601394" cy="3524563"/>
                <a:chOff x="4888532" y="28262"/>
                <a:chExt cx="3601394" cy="3515346"/>
              </a:xfrm>
            </p:grpSpPr>
            <p:cxnSp>
              <p:nvCxnSpPr>
                <p:cNvPr id="79" name="Straight Connector 78">
                  <a:extLst>
                    <a:ext uri="{FF2B5EF4-FFF2-40B4-BE49-F238E27FC236}">
                      <a16:creationId xmlns:a16="http://schemas.microsoft.com/office/drawing/2014/main" id="{FA1E4FB4-5E0C-1291-3453-E3934D81EB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89926" y="28262"/>
                  <a:ext cx="0" cy="351503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AE6F4533-9F45-12DB-9D55-D19FE21ACDF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88532" y="28575"/>
                  <a:ext cx="0" cy="351503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C320A5AE-17CF-A027-BCB2-C0D72A8058C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80176" y="28575"/>
                  <a:ext cx="0" cy="351503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E472CEDE-FD0C-9D17-54A5-39DE21561F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11929" y="3562350"/>
                <a:ext cx="715277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4AF41FF4-8478-0394-F5E2-9DFC54AC36F9}"/>
                  </a:ext>
                </a:extLst>
              </p:cNvPr>
              <p:cNvSpPr txBox="1"/>
              <p:nvPr/>
            </p:nvSpPr>
            <p:spPr>
              <a:xfrm>
                <a:off x="8748188" y="-49599"/>
                <a:ext cx="330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D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FA09171E-8D17-C930-3431-3A86BE1B2AF5}"/>
                  </a:ext>
                </a:extLst>
              </p:cNvPr>
              <p:cNvSpPr txBox="1"/>
              <p:nvPr/>
            </p:nvSpPr>
            <p:spPr>
              <a:xfrm>
                <a:off x="8898584" y="3491503"/>
                <a:ext cx="330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H</a:t>
                </a:r>
                <a:endParaRPr lang="en-AU" b="1" dirty="0"/>
              </a:p>
            </p:txBody>
          </p: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F985865D-4277-4AD2-8A0E-9B9122C02F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592624" y="48807"/>
                <a:ext cx="1530608" cy="6711916"/>
              </a:xfrm>
              <a:prstGeom prst="rect">
                <a:avLst/>
              </a:prstGeom>
            </p:spPr>
          </p:pic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AC6E8294-6E37-4B8F-4F3E-B567CDFC3E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69714" y="30994"/>
                <a:ext cx="0" cy="678890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C7DCAEDC-D9E2-7134-EB54-F902E82616D5}"/>
                  </a:ext>
                </a:extLst>
              </p:cNvPr>
              <p:cNvSpPr txBox="1"/>
              <p:nvPr/>
            </p:nvSpPr>
            <p:spPr>
              <a:xfrm>
                <a:off x="10517457" y="-49599"/>
                <a:ext cx="2455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b="1" dirty="0"/>
                  <a:t>I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0D5D0D57-36F8-66EF-E8D4-6DCE1EBE607E}"/>
                  </a:ext>
                </a:extLst>
              </p:cNvPr>
              <p:cNvSpPr txBox="1"/>
              <p:nvPr/>
            </p:nvSpPr>
            <p:spPr>
              <a:xfrm>
                <a:off x="10639440" y="6047"/>
                <a:ext cx="142028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AU" sz="1000" b="1" dirty="0">
                    <a:solidFill>
                      <a:srgbClr val="00B0F0"/>
                    </a:solidFill>
                  </a:rPr>
                  <a:t>LEA protein 31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A10D4792-DC77-3C03-CA5D-8A7980BDD34C}"/>
                  </a:ext>
                </a:extLst>
              </p:cNvPr>
              <p:cNvSpPr txBox="1"/>
              <p:nvPr/>
            </p:nvSpPr>
            <p:spPr>
              <a:xfrm>
                <a:off x="10639440" y="1107027"/>
                <a:ext cx="142028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AU" sz="1000" b="1" dirty="0">
                    <a:solidFill>
                      <a:srgbClr val="00B0F0"/>
                    </a:solidFill>
                  </a:rPr>
                  <a:t>Beta-D-</a:t>
                </a:r>
                <a:r>
                  <a:rPr lang="en-AU" sz="1000" b="1" dirty="0" err="1">
                    <a:solidFill>
                      <a:srgbClr val="00B0F0"/>
                    </a:solidFill>
                  </a:rPr>
                  <a:t>xylosidase</a:t>
                </a:r>
                <a:r>
                  <a:rPr lang="en-AU" sz="1000" b="1" dirty="0">
                    <a:solidFill>
                      <a:srgbClr val="00B0F0"/>
                    </a:solidFill>
                  </a:rPr>
                  <a:t> 1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B3A7B07-66D0-17C4-0420-67B405068240}"/>
                  </a:ext>
                </a:extLst>
              </p:cNvPr>
              <p:cNvSpPr txBox="1"/>
              <p:nvPr/>
            </p:nvSpPr>
            <p:spPr>
              <a:xfrm>
                <a:off x="10639440" y="2242371"/>
                <a:ext cx="142028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AU" sz="1000" b="1" dirty="0">
                    <a:solidFill>
                      <a:srgbClr val="00B0F0"/>
                    </a:solidFill>
                  </a:rPr>
                  <a:t>Oleosin 3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39C28A8-C16B-BC01-D58D-0BEDF4AE35C2}"/>
                  </a:ext>
                </a:extLst>
              </p:cNvPr>
              <p:cNvSpPr txBox="1"/>
              <p:nvPr/>
            </p:nvSpPr>
            <p:spPr>
              <a:xfrm>
                <a:off x="10639440" y="3337130"/>
                <a:ext cx="142028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AU" sz="1000" b="1" dirty="0">
                    <a:solidFill>
                      <a:srgbClr val="00B0F0"/>
                    </a:solidFill>
                  </a:rPr>
                  <a:t>Lipoxygenase 2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026427F-4375-777A-D789-AC5C2076432C}"/>
                  </a:ext>
                </a:extLst>
              </p:cNvPr>
              <p:cNvSpPr txBox="1"/>
              <p:nvPr/>
            </p:nvSpPr>
            <p:spPr>
              <a:xfrm>
                <a:off x="10639440" y="4472483"/>
                <a:ext cx="142028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AU" sz="1000" b="1" dirty="0">
                    <a:solidFill>
                      <a:srgbClr val="00B0F0"/>
                    </a:solidFill>
                  </a:rPr>
                  <a:t>Linoleic acid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F65D810-C1B9-CA5C-CAA8-85EA7EA9B3F5}"/>
                  </a:ext>
                </a:extLst>
              </p:cNvPr>
              <p:cNvSpPr txBox="1"/>
              <p:nvPr/>
            </p:nvSpPr>
            <p:spPr>
              <a:xfrm>
                <a:off x="10639440" y="5574389"/>
                <a:ext cx="142028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AU" sz="1000" b="1" dirty="0">
                    <a:solidFill>
                      <a:srgbClr val="00B0F0"/>
                    </a:solidFill>
                  </a:rPr>
                  <a:t>Alpha-linolenic acid</a:t>
                </a:r>
              </a:p>
            </p:txBody>
          </p:sp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3B357DB6-C11C-6360-3C59-C361D81381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438525" y="3762375"/>
                <a:ext cx="7116901" cy="3037007"/>
              </a:xfrm>
              <a:prstGeom prst="rect">
                <a:avLst/>
              </a:prstGeom>
            </p:spPr>
          </p:pic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A80DF064-A347-1D2E-9778-FCFF6DB53098}"/>
                  </a:ext>
                </a:extLst>
              </p:cNvPr>
              <p:cNvGrpSpPr/>
              <p:nvPr/>
            </p:nvGrpSpPr>
            <p:grpSpPr>
              <a:xfrm>
                <a:off x="5573852" y="3563886"/>
                <a:ext cx="3378369" cy="3256014"/>
                <a:chOff x="5510213" y="3563886"/>
                <a:chExt cx="3378369" cy="3256014"/>
              </a:xfrm>
            </p:grpSpPr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AB2A9129-7F46-86D6-ED29-5E70708D00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210425" y="3563886"/>
                  <a:ext cx="0" cy="325601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Straight Connector 71">
                  <a:extLst>
                    <a:ext uri="{FF2B5EF4-FFF2-40B4-BE49-F238E27FC236}">
                      <a16:creationId xmlns:a16="http://schemas.microsoft.com/office/drawing/2014/main" id="{4B4B5A5F-C35A-C8F8-DFB9-08F44942FD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888582" y="3563886"/>
                  <a:ext cx="0" cy="325601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DE4CF4F9-CDC2-6C92-4974-B7B8DB668E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10213" y="3563886"/>
                  <a:ext cx="0" cy="325601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8275FE2-33CC-5370-F512-F60B2327B47A}"/>
                </a:ext>
              </a:extLst>
            </p:cNvPr>
            <p:cNvSpPr txBox="1"/>
            <p:nvPr/>
          </p:nvSpPr>
          <p:spPr>
            <a:xfrm>
              <a:off x="6861170" y="6092368"/>
              <a:ext cx="284329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Benzene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03725BB-BB44-814E-ED19-8ADE3F7A9A9B}"/>
                </a:ext>
              </a:extLst>
            </p:cNvPr>
            <p:cNvSpPr txBox="1"/>
            <p:nvPr/>
          </p:nvSpPr>
          <p:spPr>
            <a:xfrm>
              <a:off x="10221898" y="5319290"/>
              <a:ext cx="279610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Quinolines</a:t>
              </a:r>
              <a:endParaRPr lang="en-AU" sz="5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0AB184C-7890-CE54-265E-296B4D98D2AA}"/>
                </a:ext>
              </a:extLst>
            </p:cNvPr>
            <p:cNvSpPr txBox="1"/>
            <p:nvPr/>
          </p:nvSpPr>
          <p:spPr>
            <a:xfrm>
              <a:off x="10179988" y="6046447"/>
              <a:ext cx="36434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Benzo</a:t>
              </a:r>
            </a:p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pyran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A54A577-85C2-8214-0013-28B5A0D36CF8}"/>
                </a:ext>
              </a:extLst>
            </p:cNvPr>
            <p:cNvSpPr txBox="1"/>
            <p:nvPr/>
          </p:nvSpPr>
          <p:spPr>
            <a:xfrm>
              <a:off x="6471472" y="6077191"/>
              <a:ext cx="278083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Coumarin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209754B-8593-9659-B8BD-EC53B78269BB}"/>
                </a:ext>
              </a:extLst>
            </p:cNvPr>
            <p:cNvSpPr txBox="1"/>
            <p:nvPr/>
          </p:nvSpPr>
          <p:spPr>
            <a:xfrm>
              <a:off x="6113524" y="5853209"/>
              <a:ext cx="17938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Fatty acyl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6865963-B311-A101-3DF2-2BC4A8BAC1FE}"/>
                </a:ext>
              </a:extLst>
            </p:cNvPr>
            <p:cNvSpPr txBox="1"/>
            <p:nvPr/>
          </p:nvSpPr>
          <p:spPr>
            <a:xfrm>
              <a:off x="6106380" y="4664993"/>
              <a:ext cx="17938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Prenol</a:t>
              </a:r>
              <a:r>
                <a:rPr lang="en-US" sz="500" dirty="0"/>
                <a:t> lipids</a:t>
              </a:r>
              <a:endParaRPr lang="en-AU" sz="5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87084D6-48F3-629F-0237-890CD3771731}"/>
                </a:ext>
              </a:extLst>
            </p:cNvPr>
            <p:cNvSpPr txBox="1"/>
            <p:nvPr/>
          </p:nvSpPr>
          <p:spPr>
            <a:xfrm>
              <a:off x="6092200" y="4350071"/>
              <a:ext cx="216399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Steroids</a:t>
              </a:r>
              <a:endParaRPr lang="en-AU" sz="5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211030E-ECC3-E77D-B717-05EA99577DD0}"/>
                </a:ext>
              </a:extLst>
            </p:cNvPr>
            <p:cNvSpPr txBox="1"/>
            <p:nvPr/>
          </p:nvSpPr>
          <p:spPr>
            <a:xfrm>
              <a:off x="5920528" y="5056859"/>
              <a:ext cx="56537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Glycero</a:t>
              </a:r>
              <a:endParaRPr lang="en-US" sz="500" dirty="0"/>
            </a:p>
            <a:p>
              <a:pPr algn="ctr"/>
              <a:r>
                <a:rPr lang="en-US" sz="500" dirty="0"/>
                <a:t>phospholipids</a:t>
              </a:r>
              <a:endParaRPr lang="en-AU" sz="5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5F18D34-9966-311D-982E-D7992E4384A1}"/>
                </a:ext>
              </a:extLst>
            </p:cNvPr>
            <p:cNvSpPr txBox="1"/>
            <p:nvPr/>
          </p:nvSpPr>
          <p:spPr>
            <a:xfrm>
              <a:off x="6018483" y="5399712"/>
              <a:ext cx="371089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Glycero</a:t>
              </a:r>
              <a:endParaRPr lang="en-US" sz="500" dirty="0"/>
            </a:p>
            <a:p>
              <a:pPr algn="ctr"/>
              <a:r>
                <a:rPr lang="en-US" sz="500" dirty="0"/>
                <a:t>lipids</a:t>
              </a:r>
              <a:endParaRPr lang="en-AU" sz="5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8C511D5-6551-FB5A-BA51-5A2FA0AFA717}"/>
                </a:ext>
              </a:extLst>
            </p:cNvPr>
            <p:cNvSpPr txBox="1"/>
            <p:nvPr/>
          </p:nvSpPr>
          <p:spPr>
            <a:xfrm>
              <a:off x="6470570" y="5250448"/>
              <a:ext cx="278083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Flavonoids</a:t>
              </a:r>
              <a:endParaRPr lang="en-AU" sz="50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5BB697D-97FE-7B5F-3911-A8FE1258F30E}"/>
                </a:ext>
              </a:extLst>
            </p:cNvPr>
            <p:cNvSpPr txBox="1"/>
            <p:nvPr/>
          </p:nvSpPr>
          <p:spPr>
            <a:xfrm>
              <a:off x="9444091" y="6050503"/>
              <a:ext cx="27808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Cinnamic acid</a:t>
              </a:r>
              <a:endParaRPr lang="en-AU" sz="5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3CCF81A-3AB1-BE35-AF93-5649EB3D3252}"/>
                </a:ext>
              </a:extLst>
            </p:cNvPr>
            <p:cNvSpPr txBox="1"/>
            <p:nvPr/>
          </p:nvSpPr>
          <p:spPr>
            <a:xfrm>
              <a:off x="8551831" y="6182551"/>
              <a:ext cx="333066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Carboxylic acids</a:t>
              </a:r>
              <a:endParaRPr lang="en-AU" sz="500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40BC1E9-84F3-E3BD-9692-7EA55D2C7B14}"/>
                </a:ext>
              </a:extLst>
            </p:cNvPr>
            <p:cNvSpPr txBox="1"/>
            <p:nvPr/>
          </p:nvSpPr>
          <p:spPr>
            <a:xfrm>
              <a:off x="6485210" y="4588049"/>
              <a:ext cx="252357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Stilbenes</a:t>
              </a:r>
              <a:endParaRPr lang="en-AU" sz="50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42F668D-8E50-4F86-391D-031A8A735E26}"/>
                </a:ext>
              </a:extLst>
            </p:cNvPr>
            <p:cNvSpPr txBox="1"/>
            <p:nvPr/>
          </p:nvSpPr>
          <p:spPr>
            <a:xfrm>
              <a:off x="6439311" y="4762527"/>
              <a:ext cx="34060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Diaryl</a:t>
              </a:r>
              <a:endParaRPr lang="en-US" sz="500" dirty="0"/>
            </a:p>
            <a:p>
              <a:pPr algn="ctr"/>
              <a:r>
                <a:rPr lang="en-US" sz="500" dirty="0" err="1"/>
                <a:t>propanoids</a:t>
              </a:r>
              <a:endParaRPr lang="en-AU" sz="500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87343DB-45DC-FC1D-3A8D-090B7F4016DB}"/>
                </a:ext>
              </a:extLst>
            </p:cNvPr>
            <p:cNvSpPr txBox="1"/>
            <p:nvPr/>
          </p:nvSpPr>
          <p:spPr>
            <a:xfrm>
              <a:off x="6447211" y="4946010"/>
              <a:ext cx="340602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isoflavonoids</a:t>
              </a:r>
              <a:endParaRPr lang="en-AU" sz="500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0A059B67-9397-AED6-FF45-97FCE0E5B3E8}"/>
                </a:ext>
              </a:extLst>
            </p:cNvPr>
            <p:cNvSpPr txBox="1"/>
            <p:nvPr/>
          </p:nvSpPr>
          <p:spPr>
            <a:xfrm>
              <a:off x="6445251" y="5792854"/>
              <a:ext cx="34060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Diaryl</a:t>
              </a:r>
              <a:endParaRPr lang="en-US" sz="500" dirty="0"/>
            </a:p>
            <a:p>
              <a:pPr algn="ctr"/>
              <a:r>
                <a:rPr lang="en-US" sz="500" dirty="0" err="1"/>
                <a:t>heptanoids</a:t>
              </a:r>
              <a:endParaRPr lang="en-AU" sz="500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60A57BC-A1C1-CE96-8642-F7E4A5265129}"/>
                </a:ext>
              </a:extLst>
            </p:cNvPr>
            <p:cNvSpPr txBox="1"/>
            <p:nvPr/>
          </p:nvSpPr>
          <p:spPr>
            <a:xfrm>
              <a:off x="6854716" y="5717086"/>
              <a:ext cx="284329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Phenol ester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5B4C616-3FA8-86AB-C194-2B10598BFD65}"/>
                </a:ext>
              </a:extLst>
            </p:cNvPr>
            <p:cNvSpPr txBox="1"/>
            <p:nvPr/>
          </p:nvSpPr>
          <p:spPr>
            <a:xfrm>
              <a:off x="6861128" y="5556078"/>
              <a:ext cx="284329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Phenol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AF5B74F-E305-324B-D8CB-5EC40007D1F6}"/>
                </a:ext>
              </a:extLst>
            </p:cNvPr>
            <p:cNvSpPr txBox="1"/>
            <p:nvPr/>
          </p:nvSpPr>
          <p:spPr>
            <a:xfrm>
              <a:off x="7795630" y="6156556"/>
              <a:ext cx="278083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Coumarin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EDA36EC-F47D-97EE-4ABA-D247ADA2DD84}"/>
                </a:ext>
              </a:extLst>
            </p:cNvPr>
            <p:cNvSpPr txBox="1"/>
            <p:nvPr/>
          </p:nvSpPr>
          <p:spPr>
            <a:xfrm>
              <a:off x="7794728" y="5840174"/>
              <a:ext cx="278083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Flavonoids</a:t>
              </a:r>
              <a:endParaRPr lang="en-AU" sz="5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8AFF3FC-D24B-00D5-E74A-E4F87A217E9F}"/>
                </a:ext>
              </a:extLst>
            </p:cNvPr>
            <p:cNvSpPr txBox="1"/>
            <p:nvPr/>
          </p:nvSpPr>
          <p:spPr>
            <a:xfrm>
              <a:off x="7763469" y="5421367"/>
              <a:ext cx="34060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Diaryl</a:t>
              </a:r>
              <a:endParaRPr lang="en-US" sz="500" dirty="0"/>
            </a:p>
            <a:p>
              <a:pPr algn="ctr"/>
              <a:r>
                <a:rPr lang="en-US" sz="500" dirty="0" err="1"/>
                <a:t>propanoids</a:t>
              </a:r>
              <a:endParaRPr lang="en-AU" sz="500" dirty="0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A6F688B-C8B3-89DF-85DA-C4FB3DF8F8A1}"/>
                </a:ext>
              </a:extLst>
            </p:cNvPr>
            <p:cNvSpPr txBox="1"/>
            <p:nvPr/>
          </p:nvSpPr>
          <p:spPr>
            <a:xfrm>
              <a:off x="7771369" y="5636746"/>
              <a:ext cx="340602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isoflavonoids</a:t>
              </a:r>
              <a:endParaRPr lang="en-AU" sz="500" dirty="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79227F6-733E-E14F-6549-098BB3A82203}"/>
                </a:ext>
              </a:extLst>
            </p:cNvPr>
            <p:cNvSpPr txBox="1"/>
            <p:nvPr/>
          </p:nvSpPr>
          <p:spPr>
            <a:xfrm>
              <a:off x="8231939" y="5679722"/>
              <a:ext cx="17938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Prenol</a:t>
              </a:r>
              <a:r>
                <a:rPr lang="en-US" sz="500" dirty="0"/>
                <a:t> lipids</a:t>
              </a:r>
              <a:endParaRPr lang="en-AU" sz="500" dirty="0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1E76940-AE96-5114-3516-27D26CEBD732}"/>
                </a:ext>
              </a:extLst>
            </p:cNvPr>
            <p:cNvSpPr txBox="1"/>
            <p:nvPr/>
          </p:nvSpPr>
          <p:spPr>
            <a:xfrm>
              <a:off x="8217759" y="5407328"/>
              <a:ext cx="216399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Steroids</a:t>
              </a:r>
              <a:endParaRPr lang="en-AU" sz="500" dirty="0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AE5A44F-6ADD-1442-52C3-BFF7DAFEF9AA}"/>
                </a:ext>
              </a:extLst>
            </p:cNvPr>
            <p:cNvSpPr txBox="1"/>
            <p:nvPr/>
          </p:nvSpPr>
          <p:spPr>
            <a:xfrm>
              <a:off x="8110964" y="6036958"/>
              <a:ext cx="447381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Glycero</a:t>
              </a:r>
              <a:endParaRPr lang="en-US" sz="500" dirty="0"/>
            </a:p>
            <a:p>
              <a:pPr algn="ctr"/>
              <a:r>
                <a:rPr lang="en-US" sz="500" dirty="0"/>
                <a:t>phospholipids</a:t>
              </a:r>
              <a:endParaRPr lang="en-AU" sz="500" dirty="0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822EB223-59D4-B9B5-F3D0-6C651D609BA4}"/>
                </a:ext>
              </a:extLst>
            </p:cNvPr>
            <p:cNvSpPr txBox="1"/>
            <p:nvPr/>
          </p:nvSpPr>
          <p:spPr>
            <a:xfrm>
              <a:off x="8548858" y="6007243"/>
              <a:ext cx="333066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Hydroxy acids</a:t>
              </a:r>
              <a:endParaRPr lang="en-AU" sz="500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D627760-EB04-CC69-0C62-49363339691D}"/>
                </a:ext>
              </a:extLst>
            </p:cNvPr>
            <p:cNvSpPr txBox="1"/>
            <p:nvPr/>
          </p:nvSpPr>
          <p:spPr>
            <a:xfrm>
              <a:off x="9403883" y="4649946"/>
              <a:ext cx="34060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Diaryl</a:t>
              </a:r>
              <a:endParaRPr lang="en-US" sz="500" dirty="0"/>
            </a:p>
            <a:p>
              <a:pPr algn="ctr"/>
              <a:r>
                <a:rPr lang="en-US" sz="500" dirty="0" err="1"/>
                <a:t>propanoids</a:t>
              </a:r>
              <a:endParaRPr lang="en-AU" sz="500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27205F40-EF0B-63C8-0FE4-99D6A66A1E2A}"/>
                </a:ext>
              </a:extLst>
            </p:cNvPr>
            <p:cNvSpPr txBox="1"/>
            <p:nvPr/>
          </p:nvSpPr>
          <p:spPr>
            <a:xfrm>
              <a:off x="9430170" y="5189410"/>
              <a:ext cx="278083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Flavonoids</a:t>
              </a:r>
              <a:endParaRPr lang="en-AU" sz="500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B24C7C0-250A-4AF2-0D0C-190CF078EBAF}"/>
                </a:ext>
              </a:extLst>
            </p:cNvPr>
            <p:cNvSpPr txBox="1"/>
            <p:nvPr/>
          </p:nvSpPr>
          <p:spPr>
            <a:xfrm>
              <a:off x="9430170" y="5797831"/>
              <a:ext cx="278083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Coumarin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C51DEAEE-8C6F-D342-1DE7-0C3C37695111}"/>
                </a:ext>
              </a:extLst>
            </p:cNvPr>
            <p:cNvSpPr txBox="1"/>
            <p:nvPr/>
          </p:nvSpPr>
          <p:spPr>
            <a:xfrm>
              <a:off x="9879090" y="5165402"/>
              <a:ext cx="17938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Prenol</a:t>
              </a:r>
              <a:r>
                <a:rPr lang="en-US" sz="500" dirty="0"/>
                <a:t> lipids</a:t>
              </a:r>
              <a:endParaRPr lang="en-AU" sz="500" dirty="0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7EFDE4C3-FE23-3083-85A6-797A89E52261}"/>
                </a:ext>
              </a:extLst>
            </p:cNvPr>
            <p:cNvSpPr txBox="1"/>
            <p:nvPr/>
          </p:nvSpPr>
          <p:spPr>
            <a:xfrm>
              <a:off x="9864910" y="4701622"/>
              <a:ext cx="216399" cy="769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/>
                <a:t>Steroids</a:t>
              </a:r>
              <a:endParaRPr lang="en-AU" sz="500" dirty="0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04A6E08-F4CB-27D7-F782-26A98DB5BF78}"/>
                </a:ext>
              </a:extLst>
            </p:cNvPr>
            <p:cNvSpPr txBox="1"/>
            <p:nvPr/>
          </p:nvSpPr>
          <p:spPr>
            <a:xfrm>
              <a:off x="9758115" y="5714024"/>
              <a:ext cx="447381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 err="1"/>
                <a:t>Glycero</a:t>
              </a:r>
              <a:endParaRPr lang="en-US" sz="500" dirty="0"/>
            </a:p>
            <a:p>
              <a:pPr algn="ctr"/>
              <a:r>
                <a:rPr lang="en-US" sz="500" dirty="0"/>
                <a:t>phospholipids</a:t>
              </a:r>
              <a:endParaRPr lang="en-AU" sz="500" dirty="0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378F2C9-D7DA-1B40-C3D1-0F63A1984BE2}"/>
                </a:ext>
              </a:extLst>
            </p:cNvPr>
            <p:cNvSpPr txBox="1"/>
            <p:nvPr/>
          </p:nvSpPr>
          <p:spPr>
            <a:xfrm>
              <a:off x="9887037" y="6141255"/>
              <a:ext cx="17938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bg1"/>
                  </a:solidFill>
                </a:rPr>
                <a:t>Fatty acyls</a:t>
              </a:r>
              <a:endParaRPr lang="en-AU" sz="5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04461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olorful lines and dots&#10;&#10;Description automatically generated">
            <a:extLst>
              <a:ext uri="{FF2B5EF4-FFF2-40B4-BE49-F238E27FC236}">
                <a16:creationId xmlns:a16="http://schemas.microsoft.com/office/drawing/2014/main" id="{7617B284-8093-531E-C6C1-F2E9D492BF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76999"/>
            <a:ext cx="10728356" cy="65897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16486A4-C040-0174-A559-F5F7CEC2F865}"/>
              </a:ext>
            </a:extLst>
          </p:cNvPr>
          <p:cNvSpPr txBox="1"/>
          <p:nvPr/>
        </p:nvSpPr>
        <p:spPr>
          <a:xfrm>
            <a:off x="0" y="0"/>
            <a:ext cx="12192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200" b="1" dirty="0"/>
              <a:t>Supplementary Figure S4: </a:t>
            </a:r>
            <a:r>
              <a:rPr lang="en-AU" sz="1200" b="1" dirty="0" err="1"/>
              <a:t>MetaboAnalyst</a:t>
            </a:r>
            <a:r>
              <a:rPr lang="en-AU" sz="1200" b="1" dirty="0"/>
              <a:t> joint-pathway analysis. </a:t>
            </a:r>
            <a:r>
              <a:rPr lang="en-AU" sz="1200" dirty="0"/>
              <a:t>Network explorer view highlighting the pathways enriched during safflower seed development. </a:t>
            </a:r>
          </a:p>
        </p:txBody>
      </p:sp>
    </p:spTree>
    <p:extLst>
      <p:ext uri="{BB962C8B-B14F-4D97-AF65-F5344CB8AC3E}">
        <p14:creationId xmlns:p14="http://schemas.microsoft.com/office/powerpoint/2010/main" val="37948185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D5CD3DF-09FD-C345-A335-08EFF3AD7999}"/>
              </a:ext>
            </a:extLst>
          </p:cNvPr>
          <p:cNvSpPr txBox="1"/>
          <p:nvPr/>
        </p:nvSpPr>
        <p:spPr>
          <a:xfrm rot="16200000">
            <a:off x="-3150976" y="3139455"/>
            <a:ext cx="6817160" cy="57708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050" b="1" dirty="0"/>
              <a:t>Supplementary Figure S5: </a:t>
            </a:r>
            <a:r>
              <a:rPr lang="en-AU" sz="1050" b="1" dirty="0" err="1"/>
              <a:t>AraCyc</a:t>
            </a:r>
            <a:r>
              <a:rPr lang="en-AU" sz="1050" b="1" dirty="0"/>
              <a:t> omics data analysis mapping the pathways involved in safflower seed development. A</a:t>
            </a:r>
            <a:r>
              <a:rPr lang="en-AU" sz="1050" dirty="0"/>
              <a:t>. general cellular overview. B. Cellular overview zoomed-in on pyrimidine salvage pathway with expression profiles; C. whole Omics dashboard; D. omics dashboard drilled in on TCA cycle; E. TCA cycle pathway with profiles.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4700D871-0252-908C-3D4D-2844986C363C}"/>
              </a:ext>
            </a:extLst>
          </p:cNvPr>
          <p:cNvGrpSpPr/>
          <p:nvPr/>
        </p:nvGrpSpPr>
        <p:grpSpPr>
          <a:xfrm>
            <a:off x="433137" y="34102"/>
            <a:ext cx="11754736" cy="6802473"/>
            <a:chOff x="0" y="34102"/>
            <a:chExt cx="11834949" cy="6802473"/>
          </a:xfrm>
        </p:grpSpPr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7C1E44F5-B9AD-91CD-3D15-3DC1C98D1166}"/>
                </a:ext>
              </a:extLst>
            </p:cNvPr>
            <p:cNvSpPr/>
            <p:nvPr/>
          </p:nvSpPr>
          <p:spPr>
            <a:xfrm>
              <a:off x="78377" y="34836"/>
              <a:ext cx="11747863" cy="67930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65E0CAC-9966-0B64-5CF8-C0767BD8AE7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6200000">
              <a:off x="-1621419" y="1964928"/>
              <a:ext cx="6647454" cy="293715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392DDF5-DB64-743A-84D7-426977CCA2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6200000">
              <a:off x="1505121" y="1993601"/>
              <a:ext cx="6610764" cy="285043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1964A42-F139-7710-4578-DDF7C6D673A8}"/>
                </a:ext>
              </a:extLst>
            </p:cNvPr>
            <p:cNvSpPr txBox="1"/>
            <p:nvPr/>
          </p:nvSpPr>
          <p:spPr>
            <a:xfrm rot="16200000">
              <a:off x="22602" y="6470429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AAC4D2E-82A9-EB1E-06D8-D4EDEE0D3D90}"/>
                </a:ext>
              </a:extLst>
            </p:cNvPr>
            <p:cNvSpPr txBox="1"/>
            <p:nvPr/>
          </p:nvSpPr>
          <p:spPr>
            <a:xfrm rot="16200000">
              <a:off x="3102477" y="6470429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B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E182BA7-923D-367D-BE03-9BF6D0F13E84}"/>
                </a:ext>
              </a:extLst>
            </p:cNvPr>
            <p:cNvSpPr txBox="1"/>
            <p:nvPr/>
          </p:nvSpPr>
          <p:spPr>
            <a:xfrm rot="16200000">
              <a:off x="6267137" y="6479246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C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FCF2994-3246-04B6-50C5-A3129B19AAA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16200000">
              <a:off x="4468794" y="2178316"/>
              <a:ext cx="6648944" cy="2491925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A3C71C5E-56C4-9D59-FE39-63E15B9B321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rot="16200000">
              <a:off x="9442467" y="4461920"/>
              <a:ext cx="2042195" cy="2482366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0A5232A-CB26-1A09-9640-02B04BBCF3F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6200000">
              <a:off x="8113616" y="1035391"/>
              <a:ext cx="4516747" cy="2665521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789CA27-7BAC-C786-A9CD-9F0710997FB1}"/>
                </a:ext>
              </a:extLst>
            </p:cNvPr>
            <p:cNvSpPr txBox="1"/>
            <p:nvPr/>
          </p:nvSpPr>
          <p:spPr>
            <a:xfrm rot="16200000">
              <a:off x="9033069" y="4348903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E</a:t>
              </a: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A59EFB5D-EC97-44C7-6412-6C971DD8E82B}"/>
                </a:ext>
              </a:extLst>
            </p:cNvPr>
            <p:cNvCxnSpPr>
              <a:cxnSpLocks/>
            </p:cNvCxnSpPr>
            <p:nvPr/>
          </p:nvCxnSpPr>
          <p:spPr>
            <a:xfrm>
              <a:off x="3156851" y="34836"/>
              <a:ext cx="0" cy="6793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5754F5D1-26C0-C202-5171-4C069DD3D0B1}"/>
                </a:ext>
              </a:extLst>
            </p:cNvPr>
            <p:cNvCxnSpPr>
              <a:cxnSpLocks/>
            </p:cNvCxnSpPr>
            <p:nvPr/>
          </p:nvCxnSpPr>
          <p:spPr>
            <a:xfrm>
              <a:off x="6322443" y="34102"/>
              <a:ext cx="0" cy="6793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F69BD6CA-9BE3-289D-41C3-625254A0BEDB}"/>
                </a:ext>
              </a:extLst>
            </p:cNvPr>
            <p:cNvCxnSpPr>
              <a:cxnSpLocks/>
            </p:cNvCxnSpPr>
            <p:nvPr/>
          </p:nvCxnSpPr>
          <p:spPr>
            <a:xfrm>
              <a:off x="9044755" y="43545"/>
              <a:ext cx="0" cy="6793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EB994BFB-A54B-A86B-B713-004554E60691}"/>
                </a:ext>
              </a:extLst>
            </p:cNvPr>
            <p:cNvCxnSpPr/>
            <p:nvPr/>
          </p:nvCxnSpPr>
          <p:spPr>
            <a:xfrm flipH="1">
              <a:off x="9047938" y="4646021"/>
              <a:ext cx="27870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4C1E818-B10F-83E4-02E6-EEC3F5AFB03B}"/>
                </a:ext>
              </a:extLst>
            </p:cNvPr>
            <p:cNvSpPr txBox="1"/>
            <p:nvPr/>
          </p:nvSpPr>
          <p:spPr>
            <a:xfrm rot="16200000">
              <a:off x="9016237" y="6467223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211001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CC9AEA0-77AF-475B-802A-C40BA93199BC}"/>
              </a:ext>
            </a:extLst>
          </p:cNvPr>
          <p:cNvSpPr txBox="1"/>
          <p:nvPr/>
        </p:nvSpPr>
        <p:spPr>
          <a:xfrm>
            <a:off x="0" y="0"/>
            <a:ext cx="121920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200" b="1" dirty="0"/>
              <a:t>Supplementary Figure S6: </a:t>
            </a:r>
            <a:r>
              <a:rPr lang="en-AU" sz="1200" b="1" dirty="0" err="1"/>
              <a:t>PaintOmics</a:t>
            </a:r>
            <a:r>
              <a:rPr lang="en-AU" sz="1200" b="1" dirty="0"/>
              <a:t> analysis. KEGG pathway classification displaying the pathways involved in safflower seed development. </a:t>
            </a:r>
            <a:r>
              <a:rPr lang="en-AU" sz="1200" dirty="0"/>
              <a:t>A. Pie chart of KEGG categories; B. Enrichment map. 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40D35147-8008-4FB4-3B85-70C652A5F44A}"/>
              </a:ext>
            </a:extLst>
          </p:cNvPr>
          <p:cNvGrpSpPr/>
          <p:nvPr/>
        </p:nvGrpSpPr>
        <p:grpSpPr>
          <a:xfrm>
            <a:off x="85067" y="522357"/>
            <a:ext cx="11874704" cy="6335643"/>
            <a:chOff x="85067" y="522357"/>
            <a:chExt cx="11874704" cy="6335643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AA82371B-EAA7-BF70-1866-59E65C5FBD9B}"/>
                </a:ext>
              </a:extLst>
            </p:cNvPr>
            <p:cNvSpPr/>
            <p:nvPr/>
          </p:nvSpPr>
          <p:spPr>
            <a:xfrm>
              <a:off x="85067" y="545306"/>
              <a:ext cx="11874704" cy="63126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76A5518-D1CC-C3CC-F14D-4906D70E77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29" b="357"/>
            <a:stretch/>
          </p:blipFill>
          <p:spPr>
            <a:xfrm>
              <a:off x="4649774" y="590453"/>
              <a:ext cx="7257065" cy="616753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BCEBBFF-BD65-028A-94D0-D71DE99719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rcRect l="20412" t="40718" r="50763"/>
            <a:stretch/>
          </p:blipFill>
          <p:spPr>
            <a:xfrm>
              <a:off x="101794" y="1494342"/>
              <a:ext cx="4227684" cy="275027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E82934A-6637-2BB6-9162-1E89E90D0121}"/>
                </a:ext>
              </a:extLst>
            </p:cNvPr>
            <p:cNvSpPr txBox="1"/>
            <p:nvPr/>
          </p:nvSpPr>
          <p:spPr>
            <a:xfrm>
              <a:off x="85067" y="522357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813AC47-F2D0-6307-60C2-1F990C8CA088}"/>
                </a:ext>
              </a:extLst>
            </p:cNvPr>
            <p:cNvSpPr txBox="1"/>
            <p:nvPr/>
          </p:nvSpPr>
          <p:spPr>
            <a:xfrm>
              <a:off x="4325645" y="522357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b="1" dirty="0"/>
                <a:t>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7EBE8AD-6D6A-48D4-B68D-2853D70A6E8E}"/>
                </a:ext>
              </a:extLst>
            </p:cNvPr>
            <p:cNvSpPr txBox="1"/>
            <p:nvPr/>
          </p:nvSpPr>
          <p:spPr>
            <a:xfrm>
              <a:off x="4596842" y="632493"/>
              <a:ext cx="1920719" cy="8309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AU" sz="800" b="1" u="sng" dirty="0"/>
                <a:t>Legend</a:t>
              </a:r>
              <a:r>
                <a:rPr lang="en-AU" sz="800" dirty="0"/>
                <a:t>:</a:t>
              </a:r>
            </a:p>
            <a:p>
              <a:r>
                <a:rPr lang="en-AU" sz="800" dirty="0">
                  <a:solidFill>
                    <a:srgbClr val="007AFF"/>
                  </a:solidFill>
                </a:rPr>
                <a:t>(C) Cellular processes</a:t>
              </a:r>
            </a:p>
            <a:p>
              <a:r>
                <a:rPr lang="en-AU" sz="800" dirty="0">
                  <a:solidFill>
                    <a:srgbClr val="4CD964"/>
                  </a:solidFill>
                </a:rPr>
                <a:t>(E) Environmental Information Processing</a:t>
              </a:r>
            </a:p>
            <a:p>
              <a:r>
                <a:rPr lang="en-AU" sz="800" dirty="0">
                  <a:solidFill>
                    <a:srgbClr val="FF2D55"/>
                  </a:solidFill>
                </a:rPr>
                <a:t>(G) Genetic Information Processing</a:t>
              </a:r>
            </a:p>
            <a:p>
              <a:r>
                <a:rPr lang="en-AU" sz="800" dirty="0">
                  <a:solidFill>
                    <a:srgbClr val="5AC8FB"/>
                  </a:solidFill>
                </a:rPr>
                <a:t>(M) Metabolism</a:t>
              </a:r>
            </a:p>
            <a:p>
              <a:r>
                <a:rPr lang="en-AU" sz="800" dirty="0">
                  <a:solidFill>
                    <a:srgbClr val="C644FC"/>
                  </a:solidFill>
                </a:rPr>
                <a:t>(O) Organismal Systems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2AC01432-91FD-BE77-B843-871579AC5DB1}"/>
                </a:ext>
              </a:extLst>
            </p:cNvPr>
            <p:cNvCxnSpPr>
              <a:cxnSpLocks/>
            </p:cNvCxnSpPr>
            <p:nvPr/>
          </p:nvCxnSpPr>
          <p:spPr>
            <a:xfrm>
              <a:off x="4302269" y="545306"/>
              <a:ext cx="0" cy="63126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C8B68C2-5C56-E9AA-AFE8-35E4691D6B7F}"/>
                </a:ext>
              </a:extLst>
            </p:cNvPr>
            <p:cNvSpPr txBox="1"/>
            <p:nvPr/>
          </p:nvSpPr>
          <p:spPr>
            <a:xfrm>
              <a:off x="376952" y="637753"/>
              <a:ext cx="1920719" cy="8309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AU" sz="800" b="1" u="sng" dirty="0"/>
                <a:t>Legend</a:t>
              </a:r>
              <a:r>
                <a:rPr lang="en-AU" sz="800" dirty="0"/>
                <a:t>:</a:t>
              </a:r>
            </a:p>
            <a:p>
              <a:r>
                <a:rPr lang="en-AU" sz="800" dirty="0">
                  <a:solidFill>
                    <a:srgbClr val="007AFF"/>
                  </a:solidFill>
                </a:rPr>
                <a:t>(C) Cellular processes</a:t>
              </a:r>
            </a:p>
            <a:p>
              <a:r>
                <a:rPr lang="en-AU" sz="800" dirty="0">
                  <a:solidFill>
                    <a:srgbClr val="4CD964"/>
                  </a:solidFill>
                </a:rPr>
                <a:t>(E) Environmental Information Processing</a:t>
              </a:r>
            </a:p>
            <a:p>
              <a:r>
                <a:rPr lang="en-AU" sz="800" dirty="0">
                  <a:solidFill>
                    <a:srgbClr val="FF2D55"/>
                  </a:solidFill>
                </a:rPr>
                <a:t>(G) Genetic Information Processing</a:t>
              </a:r>
            </a:p>
            <a:p>
              <a:r>
                <a:rPr lang="en-AU" sz="800" dirty="0">
                  <a:solidFill>
                    <a:srgbClr val="5AC8FB"/>
                  </a:solidFill>
                </a:rPr>
                <a:t>(M) Metabolism</a:t>
              </a:r>
            </a:p>
            <a:p>
              <a:r>
                <a:rPr lang="en-AU" sz="800" dirty="0">
                  <a:solidFill>
                    <a:srgbClr val="C644FC"/>
                  </a:solidFill>
                </a:rPr>
                <a:t>(O) Organismal System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73056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5</TotalTime>
  <Words>642</Words>
  <Application>Microsoft Office PowerPoint</Application>
  <PresentationFormat>Widescreen</PresentationFormat>
  <Paragraphs>12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phine E Vincent (DEECA)</dc:creator>
  <cp:lastModifiedBy>Delphine Vincent</cp:lastModifiedBy>
  <cp:revision>120</cp:revision>
  <dcterms:created xsi:type="dcterms:W3CDTF">2023-11-27T22:59:58Z</dcterms:created>
  <dcterms:modified xsi:type="dcterms:W3CDTF">2024-03-15T04:32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0a4df9-c942-4b09-b23a-6c1023f6de27_Enabled">
    <vt:lpwstr>true</vt:lpwstr>
  </property>
  <property fmtid="{D5CDD505-2E9C-101B-9397-08002B2CF9AE}" pid="3" name="MSIP_Label_d00a4df9-c942-4b09-b23a-6c1023f6de27_SetDate">
    <vt:lpwstr>2023-11-27T23:00:05Z</vt:lpwstr>
  </property>
  <property fmtid="{D5CDD505-2E9C-101B-9397-08002B2CF9AE}" pid="4" name="MSIP_Label_d00a4df9-c942-4b09-b23a-6c1023f6de27_Method">
    <vt:lpwstr>Privileged</vt:lpwstr>
  </property>
  <property fmtid="{D5CDD505-2E9C-101B-9397-08002B2CF9AE}" pid="5" name="MSIP_Label_d00a4df9-c942-4b09-b23a-6c1023f6de27_Name">
    <vt:lpwstr>Official (DJPR)</vt:lpwstr>
  </property>
  <property fmtid="{D5CDD505-2E9C-101B-9397-08002B2CF9AE}" pid="6" name="MSIP_Label_d00a4df9-c942-4b09-b23a-6c1023f6de27_SiteId">
    <vt:lpwstr>722ea0be-3e1c-4b11-ad6f-9401d6856e24</vt:lpwstr>
  </property>
  <property fmtid="{D5CDD505-2E9C-101B-9397-08002B2CF9AE}" pid="7" name="MSIP_Label_d00a4df9-c942-4b09-b23a-6c1023f6de27_ActionId">
    <vt:lpwstr>55ef33db-3765-4fb2-9e04-2eb715ef9a95</vt:lpwstr>
  </property>
  <property fmtid="{D5CDD505-2E9C-101B-9397-08002B2CF9AE}" pid="8" name="MSIP_Label_d00a4df9-c942-4b09-b23a-6c1023f6de27_ContentBits">
    <vt:lpwstr>3</vt:lpwstr>
  </property>
  <property fmtid="{D5CDD505-2E9C-101B-9397-08002B2CF9AE}" pid="9" name="ClassificationContentMarkingHeaderLocations">
    <vt:lpwstr>Office Theme:9</vt:lpwstr>
  </property>
  <property fmtid="{D5CDD505-2E9C-101B-9397-08002B2CF9AE}" pid="10" name="ClassificationContentMarkingHeaderText">
    <vt:lpwstr>OFFICIAL</vt:lpwstr>
  </property>
  <property fmtid="{D5CDD505-2E9C-101B-9397-08002B2CF9AE}" pid="11" name="MSIP_Label_4257e2ab-f512-40e2-9c9a-c64247360765_Enabled">
    <vt:lpwstr>true</vt:lpwstr>
  </property>
  <property fmtid="{D5CDD505-2E9C-101B-9397-08002B2CF9AE}" pid="12" name="MSIP_Label_4257e2ab-f512-40e2-9c9a-c64247360765_SetDate">
    <vt:lpwstr>2023-12-11T22:02:19Z</vt:lpwstr>
  </property>
  <property fmtid="{D5CDD505-2E9C-101B-9397-08002B2CF9AE}" pid="13" name="MSIP_Label_4257e2ab-f512-40e2-9c9a-c64247360765_Method">
    <vt:lpwstr>Privileged</vt:lpwstr>
  </property>
  <property fmtid="{D5CDD505-2E9C-101B-9397-08002B2CF9AE}" pid="14" name="MSIP_Label_4257e2ab-f512-40e2-9c9a-c64247360765_Name">
    <vt:lpwstr>OFFICIAL</vt:lpwstr>
  </property>
  <property fmtid="{D5CDD505-2E9C-101B-9397-08002B2CF9AE}" pid="15" name="MSIP_Label_4257e2ab-f512-40e2-9c9a-c64247360765_SiteId">
    <vt:lpwstr>e8bdd6f7-fc18-4e48-a554-7f547927223b</vt:lpwstr>
  </property>
  <property fmtid="{D5CDD505-2E9C-101B-9397-08002B2CF9AE}" pid="16" name="MSIP_Label_4257e2ab-f512-40e2-9c9a-c64247360765_ActionId">
    <vt:lpwstr>68f1c612-3a57-4f18-864e-5b267d1f9f0a</vt:lpwstr>
  </property>
  <property fmtid="{D5CDD505-2E9C-101B-9397-08002B2CF9AE}" pid="17" name="MSIP_Label_4257e2ab-f512-40e2-9c9a-c64247360765_ContentBits">
    <vt:lpwstr>2</vt:lpwstr>
  </property>
  <property fmtid="{D5CDD505-2E9C-101B-9397-08002B2CF9AE}" pid="18" name="ClassificationContentMarkingFooterLocations">
    <vt:lpwstr>Office Theme:10</vt:lpwstr>
  </property>
  <property fmtid="{D5CDD505-2E9C-101B-9397-08002B2CF9AE}" pid="19" name="ClassificationContentMarkingFooterText">
    <vt:lpwstr>OFFICIAL</vt:lpwstr>
  </property>
</Properties>
</file>